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57" d="100"/>
          <a:sy n="57" d="100"/>
        </p:scale>
        <p:origin x="92" y="4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2A558-BCF2-4F85-8451-35860653FB22}" type="datetimeFigureOut">
              <a:rPr lang="ko-KR" altLang="en-US" smtClean="0"/>
              <a:t>2022-06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79454-42A0-43BD-88CC-0E4F15372C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700524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2A558-BCF2-4F85-8451-35860653FB22}" type="datetimeFigureOut">
              <a:rPr lang="ko-KR" altLang="en-US" smtClean="0"/>
              <a:t>2022-06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79454-42A0-43BD-88CC-0E4F15372C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68435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2A558-BCF2-4F85-8451-35860653FB22}" type="datetimeFigureOut">
              <a:rPr lang="ko-KR" altLang="en-US" smtClean="0"/>
              <a:t>2022-06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79454-42A0-43BD-88CC-0E4F15372C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89555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2A558-BCF2-4F85-8451-35860653FB22}" type="datetimeFigureOut">
              <a:rPr lang="ko-KR" altLang="en-US" smtClean="0"/>
              <a:t>2022-06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79454-42A0-43BD-88CC-0E4F15372C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23460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2A558-BCF2-4F85-8451-35860653FB22}" type="datetimeFigureOut">
              <a:rPr lang="ko-KR" altLang="en-US" smtClean="0"/>
              <a:t>2022-06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79454-42A0-43BD-88CC-0E4F15372C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03321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2A558-BCF2-4F85-8451-35860653FB22}" type="datetimeFigureOut">
              <a:rPr lang="ko-KR" altLang="en-US" smtClean="0"/>
              <a:t>2022-06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79454-42A0-43BD-88CC-0E4F15372C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03960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2A558-BCF2-4F85-8451-35860653FB22}" type="datetimeFigureOut">
              <a:rPr lang="ko-KR" altLang="en-US" smtClean="0"/>
              <a:t>2022-06-2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79454-42A0-43BD-88CC-0E4F15372C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663440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2A558-BCF2-4F85-8451-35860653FB22}" type="datetimeFigureOut">
              <a:rPr lang="ko-KR" altLang="en-US" smtClean="0"/>
              <a:t>2022-06-2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79454-42A0-43BD-88CC-0E4F15372C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2996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2A558-BCF2-4F85-8451-35860653FB22}" type="datetimeFigureOut">
              <a:rPr lang="ko-KR" altLang="en-US" smtClean="0"/>
              <a:t>2022-06-2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79454-42A0-43BD-88CC-0E4F15372C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452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2A558-BCF2-4F85-8451-35860653FB22}" type="datetimeFigureOut">
              <a:rPr lang="ko-KR" altLang="en-US" smtClean="0"/>
              <a:t>2022-06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79454-42A0-43BD-88CC-0E4F15372C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92177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2A558-BCF2-4F85-8451-35860653FB22}" type="datetimeFigureOut">
              <a:rPr lang="ko-KR" altLang="en-US" smtClean="0"/>
              <a:t>2022-06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79454-42A0-43BD-88CC-0E4F15372C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1875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F2A558-BCF2-4F85-8451-35860653FB22}" type="datetimeFigureOut">
              <a:rPr lang="ko-KR" altLang="en-US" smtClean="0"/>
              <a:t>2022-06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379454-42A0-43BD-88CC-0E4F15372C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291008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Original from Fig.2c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56496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. 2c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9750" y="0"/>
            <a:ext cx="8572500" cy="6858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758838" y="821606"/>
            <a:ext cx="490451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e used the parts marked with a red box, and the unused parts are PCR products for grabbing other controls.</a:t>
            </a:r>
            <a:endParaRPr lang="ko-KR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2398816" y="3028208"/>
            <a:ext cx="1852550" cy="2719449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81733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8</Words>
  <Application>Microsoft Office PowerPoint</Application>
  <PresentationFormat>와이드스크린</PresentationFormat>
  <Paragraphs>3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5" baseType="lpstr">
      <vt:lpstr>맑은 고딕</vt:lpstr>
      <vt:lpstr>Arial</vt:lpstr>
      <vt:lpstr>Office 테마</vt:lpstr>
      <vt:lpstr>Original from Fig.2c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riginal from Fig.2c</dc:title>
  <dc:creator>란드그리스</dc:creator>
  <cp:lastModifiedBy>란드그리스</cp:lastModifiedBy>
  <cp:revision>1</cp:revision>
  <dcterms:created xsi:type="dcterms:W3CDTF">2022-06-29T05:53:29Z</dcterms:created>
  <dcterms:modified xsi:type="dcterms:W3CDTF">2022-06-29T05:57:21Z</dcterms:modified>
</cp:coreProperties>
</file>